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 autoCompressPictures="0" bookmarkIdSeed="2">
  <p:sldMasterIdLst>
    <p:sldMasterId id="2147483660" r:id="rId1"/>
  </p:sldMasterIdLst>
  <p:notesMasterIdLst>
    <p:notesMasterId r:id="rId3"/>
  </p:notesMasterIdLst>
  <p:sldIdLst>
    <p:sldId id="258" r:id="rId2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0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712" y="6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D8DA6FD-2EBA-4BF6-9DDA-B364D4F79689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C703604-0067-48E4-A4C0-5F034A2E907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1024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557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0961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0583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4056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7807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644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4415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26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5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02860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272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6582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1.emf"/><Relationship Id="rId7" Type="http://schemas.openxmlformats.org/officeDocument/2006/relationships/oleObject" Target="../embeddings/oleObject2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6.emf"/><Relationship Id="rId4" Type="http://schemas.openxmlformats.org/officeDocument/2006/relationships/image" Target="../media/image2.emf"/><Relationship Id="rId9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523742"/>
              </p:ext>
            </p:extLst>
          </p:nvPr>
        </p:nvGraphicFramePr>
        <p:xfrm>
          <a:off x="2917825" y="5582708"/>
          <a:ext cx="2346325" cy="2362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822023" imgH="2841976" progId="Prism8.Document">
                  <p:embed/>
                </p:oleObj>
              </mc:Choice>
              <mc:Fallback>
                <p:oleObj name="Prism 8" r:id="rId2" imgW="2822023" imgH="284197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17825" y="5582708"/>
                        <a:ext cx="2346325" cy="2362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3" name="Group 32"/>
          <p:cNvGrpSpPr/>
          <p:nvPr/>
        </p:nvGrpSpPr>
        <p:grpSpPr>
          <a:xfrm>
            <a:off x="96176" y="5506390"/>
            <a:ext cx="2868427" cy="2356792"/>
            <a:chOff x="248753" y="5496579"/>
            <a:chExt cx="2868427" cy="2356792"/>
          </a:xfrm>
        </p:grpSpPr>
        <p:grpSp>
          <p:nvGrpSpPr>
            <p:cNvPr id="11" name="קבוצה 3">
              <a:extLst>
                <a:ext uri="{FF2B5EF4-FFF2-40B4-BE49-F238E27FC236}">
                  <a16:creationId xmlns:a16="http://schemas.microsoft.com/office/drawing/2014/main" id="{0864C9D7-2913-41F3-9F18-2B1788C072DE}"/>
                </a:ext>
              </a:extLst>
            </p:cNvPr>
            <p:cNvGrpSpPr/>
            <p:nvPr/>
          </p:nvGrpSpPr>
          <p:grpSpPr>
            <a:xfrm>
              <a:off x="367588" y="5496579"/>
              <a:ext cx="2749592" cy="2356792"/>
              <a:chOff x="1775845" y="3943287"/>
              <a:chExt cx="2749592" cy="2356792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1775845" y="3943287"/>
                <a:ext cx="2749592" cy="2356792"/>
                <a:chOff x="1775845" y="3943287"/>
                <a:chExt cx="2749592" cy="2356792"/>
              </a:xfrm>
            </p:grpSpPr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81" t="9213" r="5414" b="1707"/>
                <a:stretch/>
              </p:blipFill>
              <p:spPr>
                <a:xfrm>
                  <a:off x="1775845" y="3943287"/>
                  <a:ext cx="2749592" cy="2356792"/>
                </a:xfrm>
                <a:prstGeom prst="rect">
                  <a:avLst/>
                </a:prstGeom>
              </p:spPr>
            </p:pic>
            <p:sp>
              <p:nvSpPr>
                <p:cNvPr id="15" name="TextBox 14"/>
                <p:cNvSpPr txBox="1"/>
                <p:nvPr/>
              </p:nvSpPr>
              <p:spPr>
                <a:xfrm>
                  <a:off x="3050665" y="5992874"/>
                  <a:ext cx="498856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1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</a:rPr>
                    <a:t>CD3</a:t>
                  </a:r>
                  <a:r>
                    <a:rPr lang="el-GR" sz="1000" dirty="0">
                      <a:latin typeface="Arial" panose="020B0604020202020204" pitchFamily="34" charset="0"/>
                    </a:rPr>
                    <a:t>ε</a:t>
                  </a:r>
                  <a:endParaRPr lang="he-IL" sz="1000" dirty="0"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13" name="TextBox 19">
                <a:extLst>
                  <a:ext uri="{FF2B5EF4-FFF2-40B4-BE49-F238E27FC236}">
                    <a16:creationId xmlns:a16="http://schemas.microsoft.com/office/drawing/2014/main" id="{3DDC257E-78E7-418A-9FF5-D5FFCCB875DC}"/>
                  </a:ext>
                </a:extLst>
              </p:cNvPr>
              <p:cNvSpPr txBox="1"/>
              <p:nvPr/>
            </p:nvSpPr>
            <p:spPr>
              <a:xfrm>
                <a:off x="2079127" y="3968184"/>
                <a:ext cx="1233030" cy="553998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</a:rPr>
                  <a:t>Grey: T cells</a:t>
                </a:r>
              </a:p>
              <a:p>
                <a:pPr algn="l"/>
                <a:r>
                  <a:rPr lang="en-US" sz="1000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RED: PNM-MDSC</a:t>
                </a:r>
              </a:p>
              <a:p>
                <a:pPr algn="l"/>
                <a:r>
                  <a:rPr lang="en-US" sz="1000" dirty="0">
                    <a:solidFill>
                      <a:srgbClr val="0000FF"/>
                    </a:solidFill>
                    <a:latin typeface="Arial" panose="020B0604020202020204" pitchFamily="34" charset="0"/>
                  </a:rPr>
                  <a:t>Blue: M-MDSC</a:t>
                </a:r>
                <a:endParaRPr lang="en-US" sz="1000" dirty="0"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2" name="TextBox 21"/>
            <p:cNvSpPr txBox="1"/>
            <p:nvPr/>
          </p:nvSpPr>
          <p:spPr>
            <a:xfrm rot="16200000">
              <a:off x="77552" y="6509567"/>
              <a:ext cx="5886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1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</a:rPr>
                <a:t>Counts</a:t>
              </a:r>
              <a:endParaRPr lang="he-IL" sz="1000" dirty="0">
                <a:latin typeface="Arial" panose="020B0604020202020204" pitchFamily="34" charset="0"/>
              </a:endParaRP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100392" y="3064517"/>
            <a:ext cx="2886072" cy="2068830"/>
            <a:chOff x="298029" y="3252633"/>
            <a:chExt cx="2886072" cy="2068830"/>
          </a:xfrm>
        </p:grpSpPr>
        <p:grpSp>
          <p:nvGrpSpPr>
            <p:cNvPr id="6" name="קבוצה 1">
              <a:extLst>
                <a:ext uri="{FF2B5EF4-FFF2-40B4-BE49-F238E27FC236}">
                  <a16:creationId xmlns:a16="http://schemas.microsoft.com/office/drawing/2014/main" id="{3CFB0DFC-40FB-4050-829D-927A0125655B}"/>
                </a:ext>
              </a:extLst>
            </p:cNvPr>
            <p:cNvGrpSpPr/>
            <p:nvPr/>
          </p:nvGrpSpPr>
          <p:grpSpPr>
            <a:xfrm>
              <a:off x="367588" y="3252633"/>
              <a:ext cx="2816513" cy="2068830"/>
              <a:chOff x="1763688" y="1671648"/>
              <a:chExt cx="2816513" cy="206883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763688" y="1671649"/>
                <a:ext cx="2816513" cy="2068829"/>
                <a:chOff x="1763688" y="1671649"/>
                <a:chExt cx="2816513" cy="2068829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03" t="12963" r="1803" b="5143"/>
                <a:stretch/>
              </p:blipFill>
              <p:spPr>
                <a:xfrm>
                  <a:off x="1763688" y="1671649"/>
                  <a:ext cx="2816513" cy="1905858"/>
                </a:xfrm>
                <a:prstGeom prst="rect">
                  <a:avLst/>
                </a:prstGeom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3068114" y="3494257"/>
                  <a:ext cx="617478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1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</a:rPr>
                    <a:t>CD247 </a:t>
                  </a:r>
                  <a:endParaRPr lang="he-IL" sz="1000" dirty="0"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8" name="TextBox 19">
                <a:extLst>
                  <a:ext uri="{FF2B5EF4-FFF2-40B4-BE49-F238E27FC236}">
                    <a16:creationId xmlns:a16="http://schemas.microsoft.com/office/drawing/2014/main" id="{C0D596F9-6E4F-4594-8633-E61ACD7CFFCE}"/>
                  </a:ext>
                </a:extLst>
              </p:cNvPr>
              <p:cNvSpPr txBox="1"/>
              <p:nvPr/>
            </p:nvSpPr>
            <p:spPr>
              <a:xfrm>
                <a:off x="2096180" y="1671648"/>
                <a:ext cx="1021433" cy="461665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l"/>
                <a:r>
                  <a:rPr lang="en-US" sz="800" dirty="0">
                    <a:latin typeface="Arial" panose="020B0604020202020204" pitchFamily="34" charset="0"/>
                  </a:rPr>
                  <a:t>Grey: T cells</a:t>
                </a:r>
              </a:p>
              <a:p>
                <a:pPr algn="l"/>
                <a:r>
                  <a:rPr lang="en-US" sz="800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RED: PNM-MDSC</a:t>
                </a:r>
              </a:p>
              <a:p>
                <a:pPr algn="l"/>
                <a:r>
                  <a:rPr lang="en-US" sz="800" dirty="0">
                    <a:solidFill>
                      <a:srgbClr val="0000FF"/>
                    </a:solidFill>
                    <a:latin typeface="Arial" panose="020B0604020202020204" pitchFamily="34" charset="0"/>
                  </a:rPr>
                  <a:t>Blue: M-MDSC</a:t>
                </a:r>
                <a:endParaRPr lang="en-US" sz="800" dirty="0"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 rot="16200000">
              <a:off x="126828" y="3951378"/>
              <a:ext cx="5886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1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</a:rPr>
                <a:t>Counts</a:t>
              </a:r>
              <a:endParaRPr lang="he-IL" sz="1000" dirty="0">
                <a:latin typeface="Arial" panose="020B0604020202020204" pitchFamily="34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19424" y="452043"/>
            <a:ext cx="314510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A</a:t>
            </a:r>
            <a:endParaRPr lang="he-IL" sz="1400" b="1" dirty="0">
              <a:latin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-12306" y="5155899"/>
            <a:ext cx="314510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C</a:t>
            </a:r>
            <a:endParaRPr lang="he-IL" sz="1400" b="1" dirty="0">
              <a:latin typeface="Arial" panose="020B0604020202020204" pitchFamily="34" charset="0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66202" y="739325"/>
            <a:ext cx="2930131" cy="1969034"/>
            <a:chOff x="218624" y="758508"/>
            <a:chExt cx="3545459" cy="2382530"/>
          </a:xfrm>
        </p:grpSpPr>
        <p:grpSp>
          <p:nvGrpSpPr>
            <p:cNvPr id="17" name="קבוצה 2">
              <a:extLst>
                <a:ext uri="{FF2B5EF4-FFF2-40B4-BE49-F238E27FC236}">
                  <a16:creationId xmlns:a16="http://schemas.microsoft.com/office/drawing/2014/main" id="{439BD417-3F89-45FB-BF60-8B645EF8EE7F}"/>
                </a:ext>
              </a:extLst>
            </p:cNvPr>
            <p:cNvGrpSpPr/>
            <p:nvPr/>
          </p:nvGrpSpPr>
          <p:grpSpPr>
            <a:xfrm>
              <a:off x="319462" y="758508"/>
              <a:ext cx="3444621" cy="2222945"/>
              <a:chOff x="2757683" y="2601573"/>
              <a:chExt cx="3444621" cy="2222945"/>
            </a:xfrm>
          </p:grpSpPr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6" t="10266" r="3340" b="3670"/>
              <a:stretch/>
            </p:blipFill>
            <p:spPr>
              <a:xfrm>
                <a:off x="2757683" y="2622841"/>
                <a:ext cx="3444621" cy="2201677"/>
              </a:xfrm>
              <a:prstGeom prst="rect">
                <a:avLst/>
              </a:prstGeom>
            </p:spPr>
          </p:pic>
          <p:sp>
            <p:nvSpPr>
              <p:cNvPr id="19" name="TextBox 19">
                <a:extLst>
                  <a:ext uri="{FF2B5EF4-FFF2-40B4-BE49-F238E27FC236}">
                    <a16:creationId xmlns:a16="http://schemas.microsoft.com/office/drawing/2014/main" id="{4DD7D38E-59CA-4A1E-8906-38EA7A1FEDF9}"/>
                  </a:ext>
                </a:extLst>
              </p:cNvPr>
              <p:cNvSpPr txBox="1"/>
              <p:nvPr/>
            </p:nvSpPr>
            <p:spPr>
              <a:xfrm>
                <a:off x="3131840" y="2601573"/>
                <a:ext cx="1224296" cy="558614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l"/>
                <a:r>
                  <a:rPr lang="en-US" sz="800" dirty="0">
                    <a:latin typeface="Arial" panose="020B0604020202020204" pitchFamily="34" charset="0"/>
                  </a:rPr>
                  <a:t>Grey: T cells</a:t>
                </a:r>
              </a:p>
              <a:p>
                <a:pPr algn="l"/>
                <a:r>
                  <a:rPr lang="en-US" sz="800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RED: M-MDSC</a:t>
                </a:r>
              </a:p>
              <a:p>
                <a:pPr algn="l"/>
                <a:r>
                  <a:rPr lang="en-US" sz="800" dirty="0">
                    <a:solidFill>
                      <a:srgbClr val="0000FF"/>
                    </a:solidFill>
                    <a:latin typeface="Arial" panose="020B0604020202020204" pitchFamily="34" charset="0"/>
                  </a:rPr>
                  <a:t>Blue: PMN-MDSC</a:t>
                </a:r>
                <a:endParaRPr lang="en-US" sz="800" dirty="0"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 rot="16200000">
              <a:off x="11470" y="1588784"/>
              <a:ext cx="712235" cy="29792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1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</a:rPr>
                <a:t>Counts</a:t>
              </a:r>
              <a:endParaRPr lang="he-IL" sz="1000" dirty="0">
                <a:latin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818187" y="2843111"/>
              <a:ext cx="636588" cy="29792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1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</a:rPr>
                <a:t>CFSE</a:t>
              </a:r>
              <a:endParaRPr lang="he-IL" sz="1000" dirty="0">
                <a:latin typeface="Arial" panose="020B0604020202020204" pitchFamily="34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9424" y="2691996"/>
            <a:ext cx="314510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B</a:t>
            </a:r>
            <a:endParaRPr lang="he-IL" sz="1400" b="1" dirty="0">
              <a:latin typeface="Arial" panose="020B0604020202020204" pitchFamily="34" charset="0"/>
            </a:endParaRPr>
          </a:p>
        </p:txBody>
      </p:sp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490FFCC7-6BA4-17EE-26B4-03175965A5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7966903"/>
              </p:ext>
            </p:extLst>
          </p:nvPr>
        </p:nvGraphicFramePr>
        <p:xfrm>
          <a:off x="2981325" y="2871845"/>
          <a:ext cx="2212975" cy="2292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826705" imgH="2919769" progId="Prism8.Document">
                  <p:embed/>
                </p:oleObj>
              </mc:Choice>
              <mc:Fallback>
                <p:oleObj name="Prism 8" r:id="rId7" imgW="2826705" imgH="2919769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8FFB6E4-363C-650D-8C5A-68E791AAFD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81325" y="2871845"/>
                        <a:ext cx="2212975" cy="2292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69E02CB5-8549-8E1A-8EB1-40BF94708D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9879126"/>
              </p:ext>
            </p:extLst>
          </p:nvPr>
        </p:nvGraphicFramePr>
        <p:xfrm>
          <a:off x="3068638" y="326409"/>
          <a:ext cx="2195512" cy="243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657441" imgH="2941018" progId="Prism8.Document">
                  <p:embed/>
                </p:oleObj>
              </mc:Choice>
              <mc:Fallback>
                <p:oleObj name="Prism 8" r:id="rId9" imgW="2657441" imgH="2941018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4015748-C00F-A00A-1EED-E46BE9B731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068638" y="326409"/>
                        <a:ext cx="2195512" cy="243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ubtitle 1">
            <a:extLst>
              <a:ext uri="{FF2B5EF4-FFF2-40B4-BE49-F238E27FC236}">
                <a16:creationId xmlns:a16="http://schemas.microsoft.com/office/drawing/2014/main" id="{B9881472-BBA4-87A3-5B87-19AE48B5CB27}"/>
              </a:ext>
            </a:extLst>
          </p:cNvPr>
          <p:cNvSpPr txBox="1">
            <a:spLocks/>
          </p:cNvSpPr>
          <p:nvPr/>
        </p:nvSpPr>
        <p:spPr>
          <a:xfrm>
            <a:off x="343094" y="8407493"/>
            <a:ext cx="6171812" cy="1050111"/>
          </a:xfrm>
          <a:prstGeom prst="rect">
            <a:avLst/>
          </a:prstGeom>
        </p:spPr>
        <p:txBody>
          <a:bodyPr/>
          <a:lstStyle>
            <a:lvl1pPr marL="171450" indent="-171450" algn="r" defTabSz="685800" rtl="1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 rtl="0">
              <a:buNone/>
            </a:pPr>
            <a:r>
              <a:rPr lang="en-US" sz="1200" b="1" dirty="0">
                <a:latin typeface="Arial (body)"/>
              </a:rPr>
              <a:t>Figure S3.</a:t>
            </a:r>
            <a:r>
              <a:rPr lang="en-US" sz="1200" dirty="0">
                <a:latin typeface="Arial (body)"/>
              </a:rPr>
              <a:t> (A) Proliferation of activated T cells co-cultured with PMN-MDSCs or M-MDSCs isolated from spleens of CAC mice at a ratio of 1:1. Representative histograms (left) are displayed, and proliferation index is summarized (right), (n=2). (B, C) Expression levels of CD247 (B) and CD3ε (C) in naïve T cells before and after co-culturing with PMN-MDSCs or M-MDSCs isolated from spleen of CAC mice at a ratio of 1:1. Representative histograms are presented (left), and expression as MFI is summarized (right), (n=2). Data representing two independent experiments are shown. Results are represented as mean ± SEM; p&lt;0.05=∗; p&lt;0.01=∗∗; p&lt;0.0001=∗∗∗∗.</a:t>
            </a:r>
            <a:endParaRPr lang="en-IL" sz="1200" dirty="0">
              <a:latin typeface="Arial (body)"/>
            </a:endParaRPr>
          </a:p>
        </p:txBody>
      </p:sp>
    </p:spTree>
    <p:extLst>
      <p:ext uri="{BB962C8B-B14F-4D97-AF65-F5344CB8AC3E}">
        <p14:creationId xmlns:p14="http://schemas.microsoft.com/office/powerpoint/2010/main" val="7648961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75</TotalTime>
  <Words>185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(body)</vt:lpstr>
      <vt:lpstr>Calibri</vt:lpstr>
      <vt:lpstr>Calibri Light</vt:lpstr>
      <vt:lpstr>Office Theme</vt:lpstr>
      <vt:lpstr>Prism 8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28.6.2021</dc:title>
  <dc:creator>Hadas Ashkenazi</dc:creator>
  <cp:lastModifiedBy>Or Reuven</cp:lastModifiedBy>
  <cp:revision>212</cp:revision>
  <dcterms:created xsi:type="dcterms:W3CDTF">2021-06-28T09:42:38Z</dcterms:created>
  <dcterms:modified xsi:type="dcterms:W3CDTF">2023-12-24T13:20:24Z</dcterms:modified>
</cp:coreProperties>
</file>